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167" r:id="rId2"/>
  </p:sldIdLst>
  <p:sldSz cx="12192000" cy="6858000"/>
  <p:notesSz cx="6858000" cy="9144000"/>
  <p:defaultTextStyle>
    <a:defPPr>
      <a:defRPr lang="en-C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 showGuides="1">
      <p:cViewPr varScale="1">
        <p:scale>
          <a:sx n="98" d="100"/>
          <a:sy n="98" d="100"/>
        </p:scale>
        <p:origin x="96" y="1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8652F1-F0C3-467D-927B-70348FE1575A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C6DE7-905F-42F0-A4AE-ABB7896D44B2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210710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F360D4B-B70F-118F-ABC2-0EB303F3F0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ACD2319B-D6BF-5983-C514-B9399D46199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ACCE2301-4FDB-067B-3A1F-DA6AF2E0429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err="1"/>
              <a:t>wendi</a:t>
            </a:r>
            <a:endParaRPr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120B7FE-01A6-E429-33BF-DC4B4ED63E6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616B83-F606-4EAD-AA1A-9D770636897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86406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3FB1B-4105-CD09-DBF1-BC4A1A5904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96501A3-EA29-A464-374F-C61AD51166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D31271-2596-9456-D102-4EAED1F54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6693F6-1527-AACF-51C6-B2CA4DA50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C333AB-AB23-B0CD-876A-5DC3A6AA6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822464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C798AB-901A-339F-57ED-9DBCB1E718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7882C9-A607-61C6-1C60-B4DB44DBCC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1B63EC-B044-63E4-9208-8DF21139E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BBF95A-5078-44F5-7A22-396BD5018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66976E-A16F-1E3E-E1EF-B09727F75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510616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1B7FB3-E6C3-DBE0-AA1B-AD74A94FC2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7B625D-703A-6652-49F3-4BE1005C5D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AD169E-2812-9AB2-2323-2D96D3020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92146E-4E35-27EE-E98D-FD9F6BC701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ABB0F1-9B03-EEBF-3A8D-8198435E0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51818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27ACE-4A3F-A495-2F88-A5E24DAABC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34C89A-101F-7B86-2D94-16A345092E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E69BD8-E64A-E728-6BD0-81C297764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9D17A1-F360-E4D3-914F-08A734045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6F143B-978D-F55B-4B77-F5D4A8B34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432182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8A900B-1EA2-7D62-BA3B-790E9A2DB0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E7C87B-A39A-D4E8-36FF-927239CC0B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68D6F-F832-F128-0CD1-C112C5A67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668987-6D5A-CEE4-FD19-0979A98C7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41FD19-6C5C-1A99-9853-79C08A18AF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565775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A98E35-7331-3307-300B-E1AA8632B0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2614C9-F5D9-3FE9-C2F7-C72EC850C4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A6545B-2CEA-FEF0-E564-7CDE7E945B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6904E5-D66C-967B-073E-0A203A68A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A5503A-B837-EA27-CF56-CAF8FACB8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ADDCFB-3CC1-7F69-B2A6-18BBBB436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892351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AD6B31-8ADC-7FCD-9ED1-B81D93973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892A52-5C0C-D857-3194-DAE3EDE913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53137E-69F7-A20B-E575-B07BDDED94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33F9B0-35E7-69EB-C8D4-BFB7DF74F7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156CD86-D464-1554-F45F-8E2D1CFD04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7BD26D-CCF3-2751-4DDD-43BA511E8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5BBED7-3382-6121-ED40-2E844B9ED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6995A0-0142-ED19-D911-555F2174A3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134274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DA165F-C1D7-CFC0-4588-1E553FD9BE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1B9D68A-7D1B-E3EE-36CC-550A35CE36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FE1DDD-1234-881F-A3B4-406B283BC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17D9BC8-197A-9668-274C-FE9C5F1C56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4174741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842D92-A08F-FE5D-5C3B-08B2671EE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FD922B3-12BB-2524-BB93-BFEB07234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40B323F-CA31-43B7-D598-429C7EC0B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474154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7DCD7A-9CF2-8DC2-F439-FEC9DCDBC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C13F1F-F4EA-DE71-6E69-22B0946677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2009FB-03FB-86C2-EFDA-FAF1E7E3FA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DA5665-0FC9-EA4A-6D10-C0E16E6D2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6213A8-B1C4-9192-94CA-12E17EBB3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B91DED-3E1D-BF75-BBB1-91A931D87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772191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188FAF-97E3-610B-B953-B874489D69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972AD15-ED4A-58C9-2789-2CFFF3DE96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9074F5-45FB-A640-DEA6-AAD3567840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AF7419-1D74-31CF-A52A-61AC0CE94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DAD404-F458-2EE7-79D6-7539D12FB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E75D5F-7CB8-C0B6-C4BF-E2CAFDBAB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638313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81F476-46BF-180D-071C-F97A6CAB4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C899AC-F2AD-1581-E15B-29E73A4ED8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040C35-E462-512C-CF34-2816266D00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8F3EC4-F324-4DDD-8336-AF986D00AE37}" type="datetimeFigureOut">
              <a:rPr lang="en-CH" smtClean="0"/>
              <a:t>14/04/2025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B10B2B-8BE1-8252-1499-B5FE2D214A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26B58B-3744-AEBB-1458-CEDBBFF676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4DF068-8A96-439C-883C-7D6D1E8E26AC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345763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54639CE-3CD3-00B1-3A17-F65C0A7694B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9272119-1A4B-7BF6-BCA0-6A1B6EB0845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56" t="8393" r="3880" b="24746"/>
          <a:stretch/>
        </p:blipFill>
        <p:spPr bwMode="auto">
          <a:xfrm>
            <a:off x="1749078" y="487709"/>
            <a:ext cx="3681017" cy="1828657"/>
          </a:xfrm>
          <a:prstGeom prst="rect">
            <a:avLst/>
          </a:prstGeom>
          <a:noFill/>
          <a:ln>
            <a:noFill/>
          </a:ln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5D8D152E-89F8-B363-59D5-65B7A86643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84" t="10313" b="3882"/>
          <a:stretch/>
        </p:blipFill>
        <p:spPr>
          <a:xfrm>
            <a:off x="1749078" y="3182904"/>
            <a:ext cx="3649959" cy="17495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F2B95050-9C68-CD59-BE97-AD7DD8CE042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91" t="13274" r="927" b="9777"/>
          <a:stretch/>
        </p:blipFill>
        <p:spPr>
          <a:xfrm>
            <a:off x="6919047" y="3143918"/>
            <a:ext cx="3622272" cy="182865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A71EAF1-7978-F9DA-844A-BF9619F62AA0}"/>
              </a:ext>
            </a:extLst>
          </p:cNvPr>
          <p:cNvSpPr txBox="1"/>
          <p:nvPr/>
        </p:nvSpPr>
        <p:spPr>
          <a:xfrm>
            <a:off x="964426" y="249027"/>
            <a:ext cx="320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lt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2038EEE-C62A-D9B2-DDDC-E0FF01E228D1}"/>
              </a:ext>
            </a:extLst>
          </p:cNvPr>
          <p:cNvSpPr txBox="1"/>
          <p:nvPr/>
        </p:nvSpPr>
        <p:spPr>
          <a:xfrm>
            <a:off x="6039214" y="249027"/>
            <a:ext cx="320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lt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E494B37C-D217-2EC7-005E-8E78F592BB1D}"/>
              </a:ext>
            </a:extLst>
          </p:cNvPr>
          <p:cNvSpPr txBox="1"/>
          <p:nvPr/>
        </p:nvSpPr>
        <p:spPr>
          <a:xfrm>
            <a:off x="964426" y="2776674"/>
            <a:ext cx="320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lt"/>
              </a:rPr>
              <a:t>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7B6394C-01F9-2447-FF7A-ABD6BC87E1A2}"/>
              </a:ext>
            </a:extLst>
          </p:cNvPr>
          <p:cNvSpPr txBox="1"/>
          <p:nvPr/>
        </p:nvSpPr>
        <p:spPr>
          <a:xfrm>
            <a:off x="6039214" y="2769173"/>
            <a:ext cx="3200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  <a:sym typeface="+mn-lt"/>
              </a:rPr>
              <a:t>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  <a:sym typeface="+mn-lt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DFA6D1B9-6409-C1C6-F848-272AEF624EF6}"/>
              </a:ext>
            </a:extLst>
          </p:cNvPr>
          <p:cNvSpPr/>
          <p:nvPr/>
        </p:nvSpPr>
        <p:spPr>
          <a:xfrm>
            <a:off x="3051317" y="1803297"/>
            <a:ext cx="838986" cy="310112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EB63F2C-3009-77B5-7506-DBCDE8A32AA0}"/>
              </a:ext>
            </a:extLst>
          </p:cNvPr>
          <p:cNvSpPr txBox="1"/>
          <p:nvPr/>
        </p:nvSpPr>
        <p:spPr>
          <a:xfrm>
            <a:off x="1247489" y="1030111"/>
            <a:ext cx="346249" cy="80467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FCAA647-A96D-AC3E-8F22-2D61A87643F5}"/>
              </a:ext>
            </a:extLst>
          </p:cNvPr>
          <p:cNvSpPr txBox="1"/>
          <p:nvPr/>
        </p:nvSpPr>
        <p:spPr>
          <a:xfrm>
            <a:off x="1472883" y="479860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44683D5-4BB5-6DC1-19BC-1A6A501E304F}"/>
              </a:ext>
            </a:extLst>
          </p:cNvPr>
          <p:cNvSpPr txBox="1"/>
          <p:nvPr/>
        </p:nvSpPr>
        <p:spPr>
          <a:xfrm>
            <a:off x="1435598" y="990279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9F2ADC7-FA6F-41CD-EB5B-FE1FEE0F70B0}"/>
              </a:ext>
            </a:extLst>
          </p:cNvPr>
          <p:cNvSpPr txBox="1"/>
          <p:nvPr/>
        </p:nvSpPr>
        <p:spPr>
          <a:xfrm>
            <a:off x="1472883" y="1541709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3CFFB28-1C82-278F-A5F4-01AFAEE14449}"/>
              </a:ext>
            </a:extLst>
          </p:cNvPr>
          <p:cNvSpPr txBox="1"/>
          <p:nvPr/>
        </p:nvSpPr>
        <p:spPr>
          <a:xfrm>
            <a:off x="1545831" y="2099753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C48D44E-786E-5A07-C64F-7F630ED72462}"/>
              </a:ext>
            </a:extLst>
          </p:cNvPr>
          <p:cNvSpPr txBox="1"/>
          <p:nvPr/>
        </p:nvSpPr>
        <p:spPr>
          <a:xfrm>
            <a:off x="3302834" y="2215197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E611609-0500-0FC2-9048-F96CE7DD8860}"/>
              </a:ext>
            </a:extLst>
          </p:cNvPr>
          <p:cNvSpPr txBox="1"/>
          <p:nvPr/>
        </p:nvSpPr>
        <p:spPr>
          <a:xfrm>
            <a:off x="2428896" y="2215197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DA3ED0B2-5EA9-C249-B329-60B8B96EC0F4}"/>
              </a:ext>
            </a:extLst>
          </p:cNvPr>
          <p:cNvSpPr txBox="1"/>
          <p:nvPr/>
        </p:nvSpPr>
        <p:spPr>
          <a:xfrm>
            <a:off x="4148197" y="2215197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372F50A1-5CFF-CA65-2C01-5A168C8AC521}"/>
              </a:ext>
            </a:extLst>
          </p:cNvPr>
          <p:cNvSpPr txBox="1"/>
          <p:nvPr/>
        </p:nvSpPr>
        <p:spPr>
          <a:xfrm>
            <a:off x="5027257" y="2215197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A5463C6A-360D-0163-FB35-7D3D874B2759}"/>
              </a:ext>
            </a:extLst>
          </p:cNvPr>
          <p:cNvSpPr txBox="1"/>
          <p:nvPr/>
        </p:nvSpPr>
        <p:spPr>
          <a:xfrm rot="16200000">
            <a:off x="2281127" y="2065267"/>
            <a:ext cx="346249" cy="107124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membrane</a:t>
            </a:r>
            <a:endParaRPr lang="zh-CN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58E30DC-0FA2-1862-7D81-3C1A50A7A13B}"/>
              </a:ext>
            </a:extLst>
          </p:cNvPr>
          <p:cNvSpPr txBox="1"/>
          <p:nvPr/>
        </p:nvSpPr>
        <p:spPr>
          <a:xfrm rot="16200000">
            <a:off x="3789086" y="2066592"/>
            <a:ext cx="346249" cy="107124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ide</a:t>
            </a:r>
            <a:endParaRPr lang="zh-CN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4AFDF23-B44D-8A43-9B46-455174908917}"/>
              </a:ext>
            </a:extLst>
          </p:cNvPr>
          <p:cNvSpPr txBox="1"/>
          <p:nvPr/>
        </p:nvSpPr>
        <p:spPr>
          <a:xfrm rot="16200000">
            <a:off x="4845602" y="2067925"/>
            <a:ext cx="346249" cy="107124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side</a:t>
            </a:r>
            <a:endParaRPr lang="zh-CN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31B3908D-7DCA-7A8C-DD9A-86525B6A1246}"/>
              </a:ext>
            </a:extLst>
          </p:cNvPr>
          <p:cNvCxnSpPr/>
          <p:nvPr/>
        </p:nvCxnSpPr>
        <p:spPr>
          <a:xfrm>
            <a:off x="3872621" y="2619940"/>
            <a:ext cx="243297" cy="0"/>
          </a:xfrm>
          <a:prstGeom prst="line">
            <a:avLst/>
          </a:prstGeom>
          <a:ln w="19050">
            <a:solidFill>
              <a:srgbClr val="2A2A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E6E91C8E-B5E1-C22A-529A-D167990780C1}"/>
              </a:ext>
            </a:extLst>
          </p:cNvPr>
          <p:cNvCxnSpPr/>
          <p:nvPr/>
        </p:nvCxnSpPr>
        <p:spPr>
          <a:xfrm>
            <a:off x="2945398" y="2619940"/>
            <a:ext cx="243297" cy="0"/>
          </a:xfrm>
          <a:prstGeom prst="line">
            <a:avLst/>
          </a:prstGeom>
          <a:ln w="19050">
            <a:solidFill>
              <a:srgbClr val="FF363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9D9F1C41-479E-9872-F832-F0FCA8218448}"/>
              </a:ext>
            </a:extLst>
          </p:cNvPr>
          <p:cNvCxnSpPr/>
          <p:nvPr/>
        </p:nvCxnSpPr>
        <p:spPr>
          <a:xfrm>
            <a:off x="5001391" y="2619940"/>
            <a:ext cx="243297" cy="0"/>
          </a:xfrm>
          <a:prstGeom prst="line">
            <a:avLst/>
          </a:prstGeom>
          <a:ln w="19050">
            <a:solidFill>
              <a:srgbClr val="FF0B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27460530-43EF-6026-CDCD-8330EE2B5069}"/>
              </a:ext>
            </a:extLst>
          </p:cNvPr>
          <p:cNvSpPr txBox="1"/>
          <p:nvPr/>
        </p:nvSpPr>
        <p:spPr>
          <a:xfrm>
            <a:off x="1506643" y="3218502"/>
            <a:ext cx="68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7F3966C1-3A74-2D21-AECA-0BF289930B1C}"/>
              </a:ext>
            </a:extLst>
          </p:cNvPr>
          <p:cNvSpPr txBox="1"/>
          <p:nvPr/>
        </p:nvSpPr>
        <p:spPr>
          <a:xfrm>
            <a:off x="1506643" y="3450581"/>
            <a:ext cx="68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F199BA03-1007-EE49-7714-2463ECA40BBA}"/>
              </a:ext>
            </a:extLst>
          </p:cNvPr>
          <p:cNvSpPr txBox="1"/>
          <p:nvPr/>
        </p:nvSpPr>
        <p:spPr>
          <a:xfrm>
            <a:off x="1506643" y="3699696"/>
            <a:ext cx="68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A9535941-8768-49E1-B95E-E11EC8F092CF}"/>
              </a:ext>
            </a:extLst>
          </p:cNvPr>
          <p:cNvSpPr txBox="1"/>
          <p:nvPr/>
        </p:nvSpPr>
        <p:spPr>
          <a:xfrm>
            <a:off x="1506643" y="3977949"/>
            <a:ext cx="68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712609CD-9F71-6D2B-B557-8C79A721A5A1}"/>
              </a:ext>
            </a:extLst>
          </p:cNvPr>
          <p:cNvSpPr txBox="1"/>
          <p:nvPr/>
        </p:nvSpPr>
        <p:spPr>
          <a:xfrm>
            <a:off x="1459018" y="4224170"/>
            <a:ext cx="68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E333DAD5-FDD6-4FFF-E600-85EAD81F53FC}"/>
              </a:ext>
            </a:extLst>
          </p:cNvPr>
          <p:cNvSpPr txBox="1"/>
          <p:nvPr/>
        </p:nvSpPr>
        <p:spPr>
          <a:xfrm>
            <a:off x="1459018" y="4473285"/>
            <a:ext cx="68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7154ABA3-639D-2518-89C4-BE971AF78D4B}"/>
              </a:ext>
            </a:extLst>
          </p:cNvPr>
          <p:cNvSpPr txBox="1"/>
          <p:nvPr/>
        </p:nvSpPr>
        <p:spPr>
          <a:xfrm>
            <a:off x="1459018" y="4751538"/>
            <a:ext cx="6867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8BA09DC7-C95C-464D-B013-D0C40D69282C}"/>
              </a:ext>
            </a:extLst>
          </p:cNvPr>
          <p:cNvSpPr txBox="1"/>
          <p:nvPr/>
        </p:nvSpPr>
        <p:spPr>
          <a:xfrm>
            <a:off x="1647525" y="4884781"/>
            <a:ext cx="177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698DE708-FAB8-5C30-67D1-4E63D82EF54F}"/>
              </a:ext>
            </a:extLst>
          </p:cNvPr>
          <p:cNvSpPr txBox="1"/>
          <p:nvPr/>
        </p:nvSpPr>
        <p:spPr>
          <a:xfrm>
            <a:off x="2435478" y="4884781"/>
            <a:ext cx="4801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DC5D1C9F-481E-B9A3-78E3-171CA992A463}"/>
              </a:ext>
            </a:extLst>
          </p:cNvPr>
          <p:cNvSpPr txBox="1"/>
          <p:nvPr/>
        </p:nvSpPr>
        <p:spPr>
          <a:xfrm>
            <a:off x="3271166" y="4879302"/>
            <a:ext cx="4801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76930023-0B22-1BBD-13AC-AAC868D3E6E7}"/>
              </a:ext>
            </a:extLst>
          </p:cNvPr>
          <p:cNvSpPr txBox="1"/>
          <p:nvPr/>
        </p:nvSpPr>
        <p:spPr>
          <a:xfrm>
            <a:off x="4123955" y="4879302"/>
            <a:ext cx="4801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FAF9DBE4-FF75-4539-BC37-FEF6BDE1490F}"/>
              </a:ext>
            </a:extLst>
          </p:cNvPr>
          <p:cNvSpPr txBox="1"/>
          <p:nvPr/>
        </p:nvSpPr>
        <p:spPr>
          <a:xfrm>
            <a:off x="4936371" y="4879301"/>
            <a:ext cx="497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2" name="组合 81">
            <a:extLst>
              <a:ext uri="{FF2B5EF4-FFF2-40B4-BE49-F238E27FC236}">
                <a16:creationId xmlns:a16="http://schemas.microsoft.com/office/drawing/2014/main" id="{37AD092B-433D-9AB0-D5F2-93E9EEEC3EA8}"/>
              </a:ext>
            </a:extLst>
          </p:cNvPr>
          <p:cNvGrpSpPr/>
          <p:nvPr/>
        </p:nvGrpSpPr>
        <p:grpSpPr>
          <a:xfrm>
            <a:off x="6564288" y="420820"/>
            <a:ext cx="4120496" cy="2186568"/>
            <a:chOff x="6509447" y="1224677"/>
            <a:chExt cx="4120496" cy="2068907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BAF52376-F0D8-CE41-FF03-C2443AD73B8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70" t="56439" r="9305" b="2777"/>
            <a:stretch/>
          </p:blipFill>
          <p:spPr bwMode="auto">
            <a:xfrm>
              <a:off x="6836519" y="1267715"/>
              <a:ext cx="3649959" cy="182865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BD7C3D26-A0C4-B9AE-1D83-BBAD4739D5E0}"/>
                </a:ext>
              </a:extLst>
            </p:cNvPr>
            <p:cNvSpPr txBox="1"/>
            <p:nvPr/>
          </p:nvSpPr>
          <p:spPr>
            <a:xfrm>
              <a:off x="6518297" y="1224677"/>
              <a:ext cx="482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7423C7CC-20CD-4892-B1F4-F2F5CF9B4A24}"/>
                </a:ext>
              </a:extLst>
            </p:cNvPr>
            <p:cNvSpPr txBox="1"/>
            <p:nvPr/>
          </p:nvSpPr>
          <p:spPr>
            <a:xfrm>
              <a:off x="6509447" y="1806130"/>
              <a:ext cx="482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034BA704-40DD-E598-292C-BB4BE3ECB855}"/>
                </a:ext>
              </a:extLst>
            </p:cNvPr>
            <p:cNvSpPr txBox="1"/>
            <p:nvPr/>
          </p:nvSpPr>
          <p:spPr>
            <a:xfrm>
              <a:off x="6509447" y="2104608"/>
              <a:ext cx="482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5950D82D-ECF7-1B89-CCFE-2B36C8DF8AC2}"/>
                </a:ext>
              </a:extLst>
            </p:cNvPr>
            <p:cNvSpPr txBox="1"/>
            <p:nvPr/>
          </p:nvSpPr>
          <p:spPr>
            <a:xfrm>
              <a:off x="6577288" y="2670200"/>
              <a:ext cx="482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57E8EBD2-FBAE-7332-7FFC-34F6912CDA8D}"/>
                </a:ext>
              </a:extLst>
            </p:cNvPr>
            <p:cNvSpPr txBox="1"/>
            <p:nvPr/>
          </p:nvSpPr>
          <p:spPr>
            <a:xfrm>
              <a:off x="6511406" y="2427115"/>
              <a:ext cx="482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5A5E226D-0F99-B169-F2D6-EE5AAD59EF07}"/>
                </a:ext>
              </a:extLst>
            </p:cNvPr>
            <p:cNvSpPr txBox="1"/>
            <p:nvPr/>
          </p:nvSpPr>
          <p:spPr>
            <a:xfrm>
              <a:off x="6518297" y="1524430"/>
              <a:ext cx="482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075F1F02-6E8C-E984-CB79-FFC8E9B4F975}"/>
                </a:ext>
              </a:extLst>
            </p:cNvPr>
            <p:cNvSpPr txBox="1"/>
            <p:nvPr/>
          </p:nvSpPr>
          <p:spPr>
            <a:xfrm>
              <a:off x="7200446" y="3016585"/>
              <a:ext cx="430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00DB1550-6C6A-3E52-F5E6-93E8CC9CFF1B}"/>
                </a:ext>
              </a:extLst>
            </p:cNvPr>
            <p:cNvSpPr txBox="1"/>
            <p:nvPr/>
          </p:nvSpPr>
          <p:spPr>
            <a:xfrm>
              <a:off x="7694953" y="3015552"/>
              <a:ext cx="430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C346E02E-6779-0D91-6029-8AFB9B451DBA}"/>
                </a:ext>
              </a:extLst>
            </p:cNvPr>
            <p:cNvSpPr txBox="1"/>
            <p:nvPr/>
          </p:nvSpPr>
          <p:spPr>
            <a:xfrm>
              <a:off x="8198985" y="3015552"/>
              <a:ext cx="430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49F4026F-16E9-20B5-6ED3-E405529D5E56}"/>
                </a:ext>
              </a:extLst>
            </p:cNvPr>
            <p:cNvSpPr txBox="1"/>
            <p:nvPr/>
          </p:nvSpPr>
          <p:spPr>
            <a:xfrm>
              <a:off x="8715523" y="3015551"/>
              <a:ext cx="430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1B002358-FC6C-E051-914A-6F139C45CF5C}"/>
                </a:ext>
              </a:extLst>
            </p:cNvPr>
            <p:cNvSpPr txBox="1"/>
            <p:nvPr/>
          </p:nvSpPr>
          <p:spPr>
            <a:xfrm>
              <a:off x="9229080" y="3015550"/>
              <a:ext cx="430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A5A6C82C-82D5-DBAD-8B15-751B40A43535}"/>
                </a:ext>
              </a:extLst>
            </p:cNvPr>
            <p:cNvSpPr txBox="1"/>
            <p:nvPr/>
          </p:nvSpPr>
          <p:spPr>
            <a:xfrm>
              <a:off x="9725194" y="3008332"/>
              <a:ext cx="430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229ECC33-510C-4EA7-4F9A-88EF9E8FAABB}"/>
                </a:ext>
              </a:extLst>
            </p:cNvPr>
            <p:cNvSpPr txBox="1"/>
            <p:nvPr/>
          </p:nvSpPr>
          <p:spPr>
            <a:xfrm>
              <a:off x="10199133" y="3008331"/>
              <a:ext cx="4308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A2F3E9A3-D7E5-BAC7-FD84-96545EF8631F}"/>
                </a:ext>
              </a:extLst>
            </p:cNvPr>
            <p:cNvSpPr txBox="1"/>
            <p:nvPr/>
          </p:nvSpPr>
          <p:spPr>
            <a:xfrm>
              <a:off x="6712929" y="3014701"/>
              <a:ext cx="482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3" name="文本框 82">
            <a:extLst>
              <a:ext uri="{FF2B5EF4-FFF2-40B4-BE49-F238E27FC236}">
                <a16:creationId xmlns:a16="http://schemas.microsoft.com/office/drawing/2014/main" id="{5CCD98DB-C466-7E81-5819-244DE470B9FD}"/>
              </a:ext>
            </a:extLst>
          </p:cNvPr>
          <p:cNvSpPr txBox="1"/>
          <p:nvPr/>
        </p:nvSpPr>
        <p:spPr>
          <a:xfrm>
            <a:off x="6312430" y="1011507"/>
            <a:ext cx="346249" cy="80467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DB010743-47F3-A5F2-27C1-717B8EB61D2A}"/>
              </a:ext>
            </a:extLst>
          </p:cNvPr>
          <p:cNvSpPr txBox="1"/>
          <p:nvPr/>
        </p:nvSpPr>
        <p:spPr>
          <a:xfrm>
            <a:off x="1250932" y="3640172"/>
            <a:ext cx="369332" cy="80467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ore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354BA3A7-C2D3-4397-9015-45C2F181C271}"/>
              </a:ext>
            </a:extLst>
          </p:cNvPr>
          <p:cNvSpPr txBox="1"/>
          <p:nvPr/>
        </p:nvSpPr>
        <p:spPr>
          <a:xfrm>
            <a:off x="3216922" y="5063047"/>
            <a:ext cx="709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o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A29B4D4F-36A8-C3CE-CDD9-49F02BEFF2C5}"/>
              </a:ext>
            </a:extLst>
          </p:cNvPr>
          <p:cNvSpPr txBox="1"/>
          <p:nvPr/>
        </p:nvSpPr>
        <p:spPr>
          <a:xfrm>
            <a:off x="8330099" y="2505103"/>
            <a:ext cx="709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o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619EEF64-B869-BACD-9E38-864FE67BBE29}"/>
              </a:ext>
            </a:extLst>
          </p:cNvPr>
          <p:cNvSpPr txBox="1"/>
          <p:nvPr/>
        </p:nvSpPr>
        <p:spPr>
          <a:xfrm>
            <a:off x="6610668" y="3347861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00612A04-48C5-0A5E-C48D-E8D5F23AF0F1}"/>
              </a:ext>
            </a:extLst>
          </p:cNvPr>
          <p:cNvSpPr txBox="1"/>
          <p:nvPr/>
        </p:nvSpPr>
        <p:spPr>
          <a:xfrm>
            <a:off x="6610668" y="3672661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2F68CEAA-CED1-41A8-369E-FA23882FBFF5}"/>
              </a:ext>
            </a:extLst>
          </p:cNvPr>
          <p:cNvSpPr txBox="1"/>
          <p:nvPr/>
        </p:nvSpPr>
        <p:spPr>
          <a:xfrm>
            <a:off x="6616719" y="3962824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293C7560-52B4-A602-B0F2-9C1E03CDADC8}"/>
              </a:ext>
            </a:extLst>
          </p:cNvPr>
          <p:cNvSpPr txBox="1"/>
          <p:nvPr/>
        </p:nvSpPr>
        <p:spPr>
          <a:xfrm>
            <a:off x="6624895" y="4300788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49440B2B-C95C-0CFF-1732-68128085DCBE}"/>
              </a:ext>
            </a:extLst>
          </p:cNvPr>
          <p:cNvSpPr txBox="1"/>
          <p:nvPr/>
        </p:nvSpPr>
        <p:spPr>
          <a:xfrm>
            <a:off x="6624895" y="4624970"/>
            <a:ext cx="482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902123D4-5415-E47D-4BAA-BD37249B1FEF}"/>
              </a:ext>
            </a:extLst>
          </p:cNvPr>
          <p:cNvSpPr txBox="1"/>
          <p:nvPr/>
        </p:nvSpPr>
        <p:spPr>
          <a:xfrm>
            <a:off x="6988290" y="4910147"/>
            <a:ext cx="286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15FE96A0-C0EA-15AF-5725-82228195FF23}"/>
              </a:ext>
            </a:extLst>
          </p:cNvPr>
          <p:cNvSpPr txBox="1"/>
          <p:nvPr/>
        </p:nvSpPr>
        <p:spPr>
          <a:xfrm>
            <a:off x="7433281" y="4910119"/>
            <a:ext cx="3513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EF5AE8E9-5ECE-E9E6-ECC7-E33FF2C900F9}"/>
              </a:ext>
            </a:extLst>
          </p:cNvPr>
          <p:cNvSpPr txBox="1"/>
          <p:nvPr/>
        </p:nvSpPr>
        <p:spPr>
          <a:xfrm>
            <a:off x="7833215" y="4913269"/>
            <a:ext cx="448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62CA6339-EA96-C13E-D445-28ABAFD958B4}"/>
              </a:ext>
            </a:extLst>
          </p:cNvPr>
          <p:cNvSpPr txBox="1"/>
          <p:nvPr/>
        </p:nvSpPr>
        <p:spPr>
          <a:xfrm>
            <a:off x="8260475" y="4910147"/>
            <a:ext cx="448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138E2D75-81E4-BF4E-F107-5D5EBE987689}"/>
              </a:ext>
            </a:extLst>
          </p:cNvPr>
          <p:cNvSpPr txBox="1"/>
          <p:nvPr/>
        </p:nvSpPr>
        <p:spPr>
          <a:xfrm>
            <a:off x="8750145" y="4910119"/>
            <a:ext cx="9375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B079C3E6-AEB7-8011-7747-345F638E6B53}"/>
              </a:ext>
            </a:extLst>
          </p:cNvPr>
          <p:cNvSpPr txBox="1"/>
          <p:nvPr/>
        </p:nvSpPr>
        <p:spPr>
          <a:xfrm>
            <a:off x="9192370" y="4910118"/>
            <a:ext cx="448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9DB3B645-D9A0-BA6A-A2B9-AF54C8E9A562}"/>
              </a:ext>
            </a:extLst>
          </p:cNvPr>
          <p:cNvSpPr txBox="1"/>
          <p:nvPr/>
        </p:nvSpPr>
        <p:spPr>
          <a:xfrm>
            <a:off x="9668192" y="4910119"/>
            <a:ext cx="448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0913E84E-E622-CD13-FF8D-9EEAB0AE0999}"/>
              </a:ext>
            </a:extLst>
          </p:cNvPr>
          <p:cNvSpPr txBox="1"/>
          <p:nvPr/>
        </p:nvSpPr>
        <p:spPr>
          <a:xfrm>
            <a:off x="10124977" y="4900593"/>
            <a:ext cx="448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0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87805A0C-3393-E67D-78A8-83A5AFBE2079}"/>
              </a:ext>
            </a:extLst>
          </p:cNvPr>
          <p:cNvSpPr txBox="1"/>
          <p:nvPr/>
        </p:nvSpPr>
        <p:spPr>
          <a:xfrm>
            <a:off x="8391553" y="5095555"/>
            <a:ext cx="7090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o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21DA9F4C-1C45-D8A3-4AEB-0B53424F882E}"/>
              </a:ext>
            </a:extLst>
          </p:cNvPr>
          <p:cNvSpPr txBox="1"/>
          <p:nvPr/>
        </p:nvSpPr>
        <p:spPr>
          <a:xfrm>
            <a:off x="1284488" y="5412410"/>
            <a:ext cx="9511122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 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6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onstruction and characterization of BHV-1 gD protein vector. (A) Transmembrane region prediction. (B) Signal peptide analysis. (C) Hydrophilicity analysis. (D) B-cell epitope prediction.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905217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Office PowerPoint</Application>
  <PresentationFormat>Widescreen</PresentationFormat>
  <Paragraphs>6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imeng Liu</dc:creator>
  <cp:lastModifiedBy>Naimeng Liu</cp:lastModifiedBy>
  <cp:revision>1</cp:revision>
  <dcterms:created xsi:type="dcterms:W3CDTF">2025-04-14T08:37:04Z</dcterms:created>
  <dcterms:modified xsi:type="dcterms:W3CDTF">2025-04-14T08:37:44Z</dcterms:modified>
</cp:coreProperties>
</file>